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5ADCE37-C918-4568-BC3D-38DA2A3A2624}" type="slidenum">
              <a:rPr b="0" lang="fr-F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 u="sng">
                <a:solidFill>
                  <a:srgbClr val="000000"/>
                </a:solidFill>
                <a:uFillTx/>
                <a:latin typeface="Calibri"/>
              </a:rPr>
              <a:t>Supplementary file, Figure 1.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 Association of baseline serum adipokine levels and radiographic joint erosive or narrowing disease progression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efined as an increase of ≥1 in erosive or narrowing SHS between inclusion and 1 year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Multivariate models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odel 1 (“base”): sex + ag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odel 2 (“metabolic”): Model 1 + BMI + HOMA-IR inde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odel 3 (“metabolic + RA”): Model 2 + CRP level + DAS28-ESR value + HAQ score + RF status + anti-CCP antibody status + presence of radiographic changes at inclus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odel 4 (“metabolic + RA + steroid”): Model 3 + steroid prescription at inclus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Espace réservé du numéro de diapositiv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B8D3900-B39E-4937-847E-8075D78A0B24}" type="slidenum">
              <a:rPr b="0" lang="fr-F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17F1A2-C1C2-4F66-BDB4-CF8BD03B781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EA3ACF-B020-4956-B834-A62735E21E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5A7796-A382-46D4-9C86-38A9BD853F2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561245-ECE2-4935-8CD0-56D73189C70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46F36F-1C2C-4942-B9E4-F9E5E20BFF3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37D1B2-FA34-4CB8-B1B7-ECE39E8121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99A359-57BB-4C72-A28C-92BCD9FE39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3DCFFE-6BCE-42AF-9E30-A89F11E2E5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E98310-FAEF-4CAE-97F8-C233B42A0E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7DBEF3-9D4F-4D25-8654-2D03CD3238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046148-0F96-43BD-B38E-CCDCD894E3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D53269-4694-4BF4-B572-77A2784959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1A305F-015A-4D90-AA1E-AEFA2A5E22FC}" type="slidenum">
              <a:rPr b="0" lang="fr-FR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7"/>
          <p:cNvSpPr/>
          <p:nvPr/>
        </p:nvSpPr>
        <p:spPr>
          <a:xfrm>
            <a:off x="179280" y="5597640"/>
            <a:ext cx="88567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ry file, Figure 1. Association of baseline serum adipokine levels and radiographic joint erosive or narrowing disease progression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efined as an increase of ≥1 in erosive or narrowing SHS between inclusion and 1 year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Data are unadjusted and adjusted odds ratios for models 1, 2, 3 and 4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Group 43"/>
          <p:cNvGrpSpPr/>
          <p:nvPr/>
        </p:nvGrpSpPr>
        <p:grpSpPr>
          <a:xfrm>
            <a:off x="7236000" y="4508640"/>
            <a:ext cx="1177920" cy="1005840"/>
            <a:chOff x="7236000" y="4508640"/>
            <a:chExt cx="1177920" cy="1005840"/>
          </a:xfrm>
        </p:grpSpPr>
        <p:sp>
          <p:nvSpPr>
            <p:cNvPr id="50" name="Text Box 103"/>
            <p:cNvSpPr/>
            <p:nvPr/>
          </p:nvSpPr>
          <p:spPr>
            <a:xfrm>
              <a:off x="7340040" y="4659120"/>
              <a:ext cx="1017360" cy="855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Calibri"/>
                </a:rPr>
                <a:t>Adjusted mode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ff"/>
                  </a:solidFill>
                  <a:latin typeface="Calibri"/>
                </a:rPr>
                <a:t>1= Model 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ff"/>
                  </a:solidFill>
                  <a:latin typeface="Calibri"/>
                </a:rPr>
                <a:t>2=Model 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ff"/>
                  </a:solidFill>
                  <a:latin typeface="Calibri"/>
                </a:rPr>
                <a:t>3=Model 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ff"/>
                  </a:solidFill>
                  <a:latin typeface="Calibri"/>
                </a:rPr>
                <a:t>4=Model 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103"/>
            <p:cNvSpPr/>
            <p:nvPr/>
          </p:nvSpPr>
          <p:spPr>
            <a:xfrm>
              <a:off x="7332480" y="4508640"/>
              <a:ext cx="1081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Calibri"/>
                </a:rPr>
                <a:t>univariate mode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8"/>
            <p:cNvSpPr/>
            <p:nvPr/>
          </p:nvSpPr>
          <p:spPr>
            <a:xfrm>
              <a:off x="7236000" y="4652640"/>
              <a:ext cx="142920" cy="0"/>
            </a:xfrm>
            <a:prstGeom prst="line">
              <a:avLst/>
            </a:prstGeom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9"/>
            <p:cNvSpPr/>
            <p:nvPr/>
          </p:nvSpPr>
          <p:spPr>
            <a:xfrm>
              <a:off x="7236000" y="4795560"/>
              <a:ext cx="142920" cy="0"/>
            </a:xfrm>
            <a:prstGeom prst="line">
              <a:avLst/>
            </a:prstGeom>
            <a:ln w="1584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4" name="Rectangle 27"/>
          <p:cNvSpPr/>
          <p:nvPr/>
        </p:nvSpPr>
        <p:spPr>
          <a:xfrm>
            <a:off x="1476360" y="477720"/>
            <a:ext cx="1368360" cy="35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alibri"/>
              </a:rPr>
              <a:t>Ero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28"/>
          <p:cNvSpPr/>
          <p:nvPr/>
        </p:nvSpPr>
        <p:spPr>
          <a:xfrm>
            <a:off x="2268360" y="476280"/>
            <a:ext cx="1368720" cy="35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alibri"/>
              </a:rPr>
              <a:t>Narrow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6" name="Group 42"/>
          <p:cNvGrpSpPr/>
          <p:nvPr/>
        </p:nvGrpSpPr>
        <p:grpSpPr>
          <a:xfrm>
            <a:off x="1116000" y="692280"/>
            <a:ext cx="6124680" cy="4448160"/>
            <a:chOff x="1116000" y="692280"/>
            <a:chExt cx="6124680" cy="4448160"/>
          </a:xfrm>
        </p:grpSpPr>
        <p:pic>
          <p:nvPicPr>
            <p:cNvPr id="57" name="Picture 2" descr=""/>
            <p:cNvPicPr/>
            <p:nvPr/>
          </p:nvPicPr>
          <p:blipFill>
            <a:blip r:embed="rId1"/>
            <a:stretch/>
          </p:blipFill>
          <p:spPr>
            <a:xfrm>
              <a:off x="1116000" y="692280"/>
              <a:ext cx="6124680" cy="4448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Text Box 11"/>
            <p:cNvSpPr/>
            <p:nvPr/>
          </p:nvSpPr>
          <p:spPr>
            <a:xfrm>
              <a:off x="1979640" y="3013200"/>
              <a:ext cx="272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ff"/>
                  </a:solidFill>
                  <a:latin typeface="Calibri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12"/>
            <p:cNvSpPr/>
            <p:nvPr/>
          </p:nvSpPr>
          <p:spPr>
            <a:xfrm>
              <a:off x="2057400" y="3017880"/>
              <a:ext cx="272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ff"/>
                  </a:solidFill>
                  <a:latin typeface="Calibri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13"/>
            <p:cNvSpPr/>
            <p:nvPr/>
          </p:nvSpPr>
          <p:spPr>
            <a:xfrm>
              <a:off x="2133720" y="2492640"/>
              <a:ext cx="272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ff"/>
                  </a:solidFill>
                  <a:latin typeface="Calibri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14"/>
            <p:cNvSpPr/>
            <p:nvPr/>
          </p:nvSpPr>
          <p:spPr>
            <a:xfrm>
              <a:off x="2224080" y="2492640"/>
              <a:ext cx="272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ff"/>
                  </a:solidFill>
                  <a:latin typeface="Calibri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15"/>
            <p:cNvSpPr/>
            <p:nvPr/>
          </p:nvSpPr>
          <p:spPr>
            <a:xfrm>
              <a:off x="2738520" y="2081160"/>
              <a:ext cx="272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ff"/>
                  </a:solidFill>
                  <a:latin typeface="Calibri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16"/>
            <p:cNvSpPr/>
            <p:nvPr/>
          </p:nvSpPr>
          <p:spPr>
            <a:xfrm>
              <a:off x="2814480" y="1673280"/>
              <a:ext cx="273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ff"/>
                  </a:solidFill>
                  <a:latin typeface="Calibri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 Box 17"/>
            <p:cNvSpPr/>
            <p:nvPr/>
          </p:nvSpPr>
          <p:spPr>
            <a:xfrm>
              <a:off x="2887560" y="1389240"/>
              <a:ext cx="273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ff"/>
                  </a:solidFill>
                  <a:latin typeface="Calibri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 Box 18"/>
            <p:cNvSpPr/>
            <p:nvPr/>
          </p:nvSpPr>
          <p:spPr>
            <a:xfrm>
              <a:off x="2975040" y="1324080"/>
              <a:ext cx="272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ff"/>
                  </a:solidFill>
                  <a:latin typeface="Calibri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 Box 19"/>
            <p:cNvSpPr/>
            <p:nvPr/>
          </p:nvSpPr>
          <p:spPr>
            <a:xfrm>
              <a:off x="3875040" y="4016520"/>
              <a:ext cx="273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ff"/>
                  </a:solidFill>
                  <a:latin typeface="Calibri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 Box 20"/>
            <p:cNvSpPr/>
            <p:nvPr/>
          </p:nvSpPr>
          <p:spPr>
            <a:xfrm>
              <a:off x="3952800" y="3349800"/>
              <a:ext cx="273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ff"/>
                  </a:solidFill>
                  <a:latin typeface="Calibri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 Box 21"/>
            <p:cNvSpPr/>
            <p:nvPr/>
          </p:nvSpPr>
          <p:spPr>
            <a:xfrm>
              <a:off x="4029120" y="2460600"/>
              <a:ext cx="272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ff"/>
                  </a:solidFill>
                  <a:latin typeface="Calibri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 Box 22"/>
            <p:cNvSpPr/>
            <p:nvPr/>
          </p:nvSpPr>
          <p:spPr>
            <a:xfrm>
              <a:off x="4114800" y="2465640"/>
              <a:ext cx="272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ff"/>
                  </a:solidFill>
                  <a:latin typeface="Calibri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 Box 23"/>
            <p:cNvSpPr/>
            <p:nvPr/>
          </p:nvSpPr>
          <p:spPr>
            <a:xfrm>
              <a:off x="4633920" y="3841920"/>
              <a:ext cx="272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ff"/>
                  </a:solidFill>
                  <a:latin typeface="Calibri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 Box 24"/>
            <p:cNvSpPr/>
            <p:nvPr/>
          </p:nvSpPr>
          <p:spPr>
            <a:xfrm>
              <a:off x="4702320" y="3257640"/>
              <a:ext cx="272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ff"/>
                  </a:solidFill>
                  <a:latin typeface="Calibri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 Box 25"/>
            <p:cNvSpPr/>
            <p:nvPr/>
          </p:nvSpPr>
          <p:spPr>
            <a:xfrm>
              <a:off x="4778280" y="3008520"/>
              <a:ext cx="273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ff"/>
                  </a:solidFill>
                  <a:latin typeface="Calibri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 Box 26"/>
            <p:cNvSpPr/>
            <p:nvPr/>
          </p:nvSpPr>
          <p:spPr>
            <a:xfrm>
              <a:off x="4873680" y="3008520"/>
              <a:ext cx="272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ff"/>
                  </a:solidFill>
                  <a:latin typeface="Calibri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 Box 34"/>
            <p:cNvSpPr/>
            <p:nvPr/>
          </p:nvSpPr>
          <p:spPr>
            <a:xfrm>
              <a:off x="5762520" y="3659400"/>
              <a:ext cx="273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ff"/>
                  </a:solidFill>
                  <a:latin typeface="Calibri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 Box 35"/>
            <p:cNvSpPr/>
            <p:nvPr/>
          </p:nvSpPr>
          <p:spPr>
            <a:xfrm>
              <a:off x="5840280" y="3646440"/>
              <a:ext cx="273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ff"/>
                  </a:solidFill>
                  <a:latin typeface="Calibri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 Box 36"/>
            <p:cNvSpPr/>
            <p:nvPr/>
          </p:nvSpPr>
          <p:spPr>
            <a:xfrm>
              <a:off x="5916600" y="3645000"/>
              <a:ext cx="273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ff"/>
                  </a:solidFill>
                  <a:latin typeface="Calibri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 Box 37"/>
            <p:cNvSpPr/>
            <p:nvPr/>
          </p:nvSpPr>
          <p:spPr>
            <a:xfrm>
              <a:off x="5992920" y="3637080"/>
              <a:ext cx="272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ff"/>
                  </a:solidFill>
                  <a:latin typeface="Calibri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 Box 38"/>
            <p:cNvSpPr/>
            <p:nvPr/>
          </p:nvSpPr>
          <p:spPr>
            <a:xfrm>
              <a:off x="6529320" y="3492720"/>
              <a:ext cx="273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ff"/>
                  </a:solidFill>
                  <a:latin typeface="Calibri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 Box 39"/>
            <p:cNvSpPr/>
            <p:nvPr/>
          </p:nvSpPr>
          <p:spPr>
            <a:xfrm>
              <a:off x="6588000" y="3635640"/>
              <a:ext cx="273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ff"/>
                  </a:solidFill>
                  <a:latin typeface="Calibri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 Box 40"/>
            <p:cNvSpPr/>
            <p:nvPr/>
          </p:nvSpPr>
          <p:spPr>
            <a:xfrm>
              <a:off x="6665760" y="3368880"/>
              <a:ext cx="273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ff"/>
                  </a:solidFill>
                  <a:latin typeface="Calibri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 Box 41"/>
            <p:cNvSpPr/>
            <p:nvPr/>
          </p:nvSpPr>
          <p:spPr>
            <a:xfrm>
              <a:off x="6765840" y="3359160"/>
              <a:ext cx="273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ff"/>
                  </a:solidFill>
                  <a:latin typeface="Calibri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2" name="Text Box 44"/>
          <p:cNvSpPr/>
          <p:nvPr/>
        </p:nvSpPr>
        <p:spPr>
          <a:xfrm>
            <a:off x="2075040" y="28404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000" spc="-1" strike="noStrike">
                <a:solidFill>
                  <a:srgbClr val="000000"/>
                </a:solidFill>
                <a:latin typeface="Calibri"/>
              </a:rPr>
              <a:t>Adiponect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45"/>
          <p:cNvSpPr/>
          <p:nvPr/>
        </p:nvSpPr>
        <p:spPr>
          <a:xfrm>
            <a:off x="4211640" y="263520"/>
            <a:ext cx="720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000" spc="-1" strike="noStrike">
                <a:solidFill>
                  <a:srgbClr val="000000"/>
                </a:solidFill>
                <a:latin typeface="Calibri"/>
              </a:rPr>
              <a:t>Lept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46"/>
          <p:cNvSpPr/>
          <p:nvPr/>
        </p:nvSpPr>
        <p:spPr>
          <a:xfrm>
            <a:off x="5796000" y="268200"/>
            <a:ext cx="113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1000" spc="-1" strike="noStrike">
                <a:solidFill>
                  <a:srgbClr val="000000"/>
                </a:solidFill>
                <a:latin typeface="Calibri"/>
              </a:rPr>
              <a:t>Visfatin/NAMP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47"/>
          <p:cNvSpPr/>
          <p:nvPr/>
        </p:nvSpPr>
        <p:spPr>
          <a:xfrm>
            <a:off x="3490920" y="490680"/>
            <a:ext cx="1368360" cy="358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alibri"/>
              </a:rPr>
              <a:t>Ero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48"/>
          <p:cNvSpPr/>
          <p:nvPr/>
        </p:nvSpPr>
        <p:spPr>
          <a:xfrm>
            <a:off x="4282920" y="490680"/>
            <a:ext cx="1368720" cy="358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alibri"/>
              </a:rPr>
              <a:t>Narrow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49"/>
          <p:cNvSpPr/>
          <p:nvPr/>
        </p:nvSpPr>
        <p:spPr>
          <a:xfrm>
            <a:off x="5291280" y="490680"/>
            <a:ext cx="1368360" cy="358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alibri"/>
              </a:rPr>
              <a:t>Ero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50"/>
          <p:cNvSpPr/>
          <p:nvPr/>
        </p:nvSpPr>
        <p:spPr>
          <a:xfrm>
            <a:off x="6083280" y="490680"/>
            <a:ext cx="1368360" cy="358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alibri"/>
              </a:rPr>
              <a:t>Narrow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18T18:31:14Z</dcterms:created>
  <dc:creator>UR4</dc:creator>
  <dc:description/>
  <dc:language>en-US</dc:language>
  <cp:lastModifiedBy>UR4</cp:lastModifiedBy>
  <dcterms:modified xsi:type="dcterms:W3CDTF">2013-04-29T15:05:12Z</dcterms:modified>
  <cp:revision>6</cp:revision>
  <dc:subject/>
  <dc:title>Diapositive 1</dc:title>
</cp:coreProperties>
</file>